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2" autoAdjust="0"/>
    <p:restoredTop sz="94660"/>
  </p:normalViewPr>
  <p:slideViewPr>
    <p:cSldViewPr snapToGrid="0">
      <p:cViewPr varScale="1">
        <p:scale>
          <a:sx n="60" d="100"/>
          <a:sy n="60" d="100"/>
        </p:scale>
        <p:origin x="187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1756B-A715-4E50-B1A3-EC46A2A5511F}" type="datetimeFigureOut">
              <a:rPr lang="en-AU" smtClean="0"/>
              <a:t>26/04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F44DFC-E9DE-44F7-AC25-E25E6BF8E1B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79707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1756B-A715-4E50-B1A3-EC46A2A5511F}" type="datetimeFigureOut">
              <a:rPr lang="en-AU" smtClean="0"/>
              <a:t>26/04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F44DFC-E9DE-44F7-AC25-E25E6BF8E1B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73726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1756B-A715-4E50-B1A3-EC46A2A5511F}" type="datetimeFigureOut">
              <a:rPr lang="en-AU" smtClean="0"/>
              <a:t>26/04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F44DFC-E9DE-44F7-AC25-E25E6BF8E1B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851079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1756B-A715-4E50-B1A3-EC46A2A5511F}" type="datetimeFigureOut">
              <a:rPr lang="en-AU" smtClean="0"/>
              <a:t>26/04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F44DFC-E9DE-44F7-AC25-E25E6BF8E1B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876058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1756B-A715-4E50-B1A3-EC46A2A5511F}" type="datetimeFigureOut">
              <a:rPr lang="en-AU" smtClean="0"/>
              <a:t>26/04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F44DFC-E9DE-44F7-AC25-E25E6BF8E1B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78519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1756B-A715-4E50-B1A3-EC46A2A5511F}" type="datetimeFigureOut">
              <a:rPr lang="en-AU" smtClean="0"/>
              <a:t>26/04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F44DFC-E9DE-44F7-AC25-E25E6BF8E1B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716790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1756B-A715-4E50-B1A3-EC46A2A5511F}" type="datetimeFigureOut">
              <a:rPr lang="en-AU" smtClean="0"/>
              <a:t>26/04/2018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F44DFC-E9DE-44F7-AC25-E25E6BF8E1B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375977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1756B-A715-4E50-B1A3-EC46A2A5511F}" type="datetimeFigureOut">
              <a:rPr lang="en-AU" smtClean="0"/>
              <a:t>26/04/2018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F44DFC-E9DE-44F7-AC25-E25E6BF8E1B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30504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1756B-A715-4E50-B1A3-EC46A2A5511F}" type="datetimeFigureOut">
              <a:rPr lang="en-AU" smtClean="0"/>
              <a:t>26/04/2018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F44DFC-E9DE-44F7-AC25-E25E6BF8E1B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4447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1756B-A715-4E50-B1A3-EC46A2A5511F}" type="datetimeFigureOut">
              <a:rPr lang="en-AU" smtClean="0"/>
              <a:t>26/04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F44DFC-E9DE-44F7-AC25-E25E6BF8E1B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603141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1756B-A715-4E50-B1A3-EC46A2A5511F}" type="datetimeFigureOut">
              <a:rPr lang="en-AU" smtClean="0"/>
              <a:t>26/04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F44DFC-E9DE-44F7-AC25-E25E6BF8E1B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109746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01756B-A715-4E50-B1A3-EC46A2A5511F}" type="datetimeFigureOut">
              <a:rPr lang="en-AU" smtClean="0"/>
              <a:t>26/04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F44DFC-E9DE-44F7-AC25-E25E6BF8E1B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11240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11002" y="842684"/>
            <a:ext cx="607741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Figure S1. </a:t>
            </a:r>
            <a:r>
              <a:rPr lang="en-AU" sz="1200" dirty="0"/>
              <a:t>Images of </a:t>
            </a:r>
            <a:r>
              <a:rPr lang="en-AU" sz="1200" i="1" dirty="0"/>
              <a:t>A. </a:t>
            </a:r>
            <a:r>
              <a:rPr lang="en-AU" sz="1200" i="1" dirty="0" err="1"/>
              <a:t>muricatus</a:t>
            </a:r>
            <a:r>
              <a:rPr lang="en-AU" sz="1200" i="1" dirty="0"/>
              <a:t> </a:t>
            </a:r>
            <a:r>
              <a:rPr lang="en-AU" sz="1200" dirty="0"/>
              <a:t>displaying limits of linear measurements (</a:t>
            </a:r>
            <a:r>
              <a:rPr lang="en-AU" sz="1200" b="1" dirty="0"/>
              <a:t>a</a:t>
            </a:r>
            <a:r>
              <a:rPr lang="en-AU" sz="1200" dirty="0"/>
              <a:t>). where cranial units are as follows: 1 = snout, 2 = orbit, 3 = post-orbit, 4 = tooth row. Two-dimensional landmarks used in these analyses (</a:t>
            </a:r>
            <a:r>
              <a:rPr lang="en-AU" sz="1200" b="1" dirty="0"/>
              <a:t>b</a:t>
            </a:r>
            <a:r>
              <a:rPr lang="en-AU" sz="1200" dirty="0"/>
              <a:t>). with landmark numbers which correspond to landmark definitions found in Additional file 2.</a:t>
            </a:r>
          </a:p>
        </p:txBody>
      </p:sp>
      <p:pic>
        <p:nvPicPr>
          <p:cNvPr id="48" name="Picture 47"/>
          <p:cNvPicPr>
            <a:picLocks noChangeAspect="1"/>
          </p:cNvPicPr>
          <p:nvPr/>
        </p:nvPicPr>
        <p:blipFill>
          <a:blip r:embed="rId2">
            <a:lum bright="20000"/>
          </a:blip>
          <a:stretch>
            <a:fillRect/>
          </a:stretch>
        </p:blipFill>
        <p:spPr>
          <a:xfrm>
            <a:off x="770162" y="2056638"/>
            <a:ext cx="5641163" cy="2880000"/>
          </a:xfrm>
          <a:prstGeom prst="rect">
            <a:avLst/>
          </a:prstGeom>
        </p:spPr>
      </p:pic>
      <p:pic>
        <p:nvPicPr>
          <p:cNvPr id="42" name="Picture 41"/>
          <p:cNvPicPr>
            <a:picLocks noChangeAspect="1"/>
          </p:cNvPicPr>
          <p:nvPr/>
        </p:nvPicPr>
        <p:blipFill>
          <a:blip r:embed="rId2">
            <a:lum bright="20000"/>
          </a:blip>
          <a:stretch>
            <a:fillRect/>
          </a:stretch>
        </p:blipFill>
        <p:spPr>
          <a:xfrm>
            <a:off x="770162" y="5353622"/>
            <a:ext cx="5641164" cy="2880000"/>
          </a:xfrm>
          <a:prstGeom prst="rect">
            <a:avLst/>
          </a:prstGeom>
        </p:spPr>
      </p:pic>
      <p:sp>
        <p:nvSpPr>
          <p:cNvPr id="6" name="Oval 5"/>
          <p:cNvSpPr/>
          <p:nvPr/>
        </p:nvSpPr>
        <p:spPr>
          <a:xfrm>
            <a:off x="795564" y="7520696"/>
            <a:ext cx="85725" cy="85725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7" name="Oval 6"/>
          <p:cNvSpPr/>
          <p:nvPr/>
        </p:nvSpPr>
        <p:spPr>
          <a:xfrm>
            <a:off x="1163069" y="7710670"/>
            <a:ext cx="85725" cy="85725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8" name="Oval 7"/>
          <p:cNvSpPr/>
          <p:nvPr/>
        </p:nvSpPr>
        <p:spPr>
          <a:xfrm>
            <a:off x="1120207" y="7293686"/>
            <a:ext cx="85725" cy="85725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9" name="Oval 8"/>
          <p:cNvSpPr/>
          <p:nvPr/>
        </p:nvSpPr>
        <p:spPr>
          <a:xfrm>
            <a:off x="1615754" y="6750759"/>
            <a:ext cx="85725" cy="85725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0" name="Oval 9"/>
          <p:cNvSpPr/>
          <p:nvPr/>
        </p:nvSpPr>
        <p:spPr>
          <a:xfrm>
            <a:off x="2698263" y="7417510"/>
            <a:ext cx="85725" cy="85725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1" name="Oval 10"/>
          <p:cNvSpPr/>
          <p:nvPr/>
        </p:nvSpPr>
        <p:spPr>
          <a:xfrm>
            <a:off x="3363985" y="7492123"/>
            <a:ext cx="85725" cy="85725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2" name="Oval 11"/>
          <p:cNvSpPr/>
          <p:nvPr/>
        </p:nvSpPr>
        <p:spPr>
          <a:xfrm>
            <a:off x="4031995" y="7755649"/>
            <a:ext cx="85725" cy="85725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3" name="Oval 12"/>
          <p:cNvSpPr/>
          <p:nvPr/>
        </p:nvSpPr>
        <p:spPr>
          <a:xfrm>
            <a:off x="2196053" y="6738060"/>
            <a:ext cx="85725" cy="85725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4" name="Oval 13"/>
          <p:cNvSpPr/>
          <p:nvPr/>
        </p:nvSpPr>
        <p:spPr>
          <a:xfrm>
            <a:off x="2698262" y="5952608"/>
            <a:ext cx="85725" cy="85725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5" name="Oval 14"/>
          <p:cNvSpPr/>
          <p:nvPr/>
        </p:nvSpPr>
        <p:spPr>
          <a:xfrm>
            <a:off x="4166932" y="6424804"/>
            <a:ext cx="85725" cy="85725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6" name="Oval 15"/>
          <p:cNvSpPr/>
          <p:nvPr/>
        </p:nvSpPr>
        <p:spPr>
          <a:xfrm>
            <a:off x="4074858" y="5607345"/>
            <a:ext cx="85725" cy="85725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7" name="Oval 16"/>
          <p:cNvSpPr/>
          <p:nvPr/>
        </p:nvSpPr>
        <p:spPr>
          <a:xfrm>
            <a:off x="4437289" y="5815188"/>
            <a:ext cx="85725" cy="85725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8" name="Oval 17"/>
          <p:cNvSpPr/>
          <p:nvPr/>
        </p:nvSpPr>
        <p:spPr>
          <a:xfrm>
            <a:off x="4802414" y="6652335"/>
            <a:ext cx="85725" cy="85725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9" name="Oval 18"/>
          <p:cNvSpPr/>
          <p:nvPr/>
        </p:nvSpPr>
        <p:spPr>
          <a:xfrm>
            <a:off x="5101102" y="6247551"/>
            <a:ext cx="85725" cy="85725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0" name="Oval 19"/>
          <p:cNvSpPr/>
          <p:nvPr/>
        </p:nvSpPr>
        <p:spPr>
          <a:xfrm>
            <a:off x="6099572" y="6299418"/>
            <a:ext cx="85725" cy="85725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1" name="Oval 20"/>
          <p:cNvSpPr/>
          <p:nvPr/>
        </p:nvSpPr>
        <p:spPr>
          <a:xfrm>
            <a:off x="4507137" y="7465136"/>
            <a:ext cx="85725" cy="85725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cxnSp>
        <p:nvCxnSpPr>
          <p:cNvPr id="23" name="Straight Connector 22"/>
          <p:cNvCxnSpPr/>
          <p:nvPr/>
        </p:nvCxnSpPr>
        <p:spPr>
          <a:xfrm>
            <a:off x="822552" y="4201575"/>
            <a:ext cx="533512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828901" y="2161950"/>
            <a:ext cx="0" cy="266216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2215738" y="2161950"/>
            <a:ext cx="0" cy="203200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4249165" y="2161950"/>
            <a:ext cx="0" cy="203962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4107085" y="4193955"/>
            <a:ext cx="0" cy="63015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6167835" y="2161950"/>
            <a:ext cx="0" cy="203200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/>
          <p:nvPr/>
        </p:nvCxnSpPr>
        <p:spPr>
          <a:xfrm>
            <a:off x="828902" y="2366404"/>
            <a:ext cx="1376676" cy="0"/>
          </a:xfrm>
          <a:prstGeom prst="straightConnector1">
            <a:avLst/>
          </a:prstGeom>
          <a:ln>
            <a:solidFill>
              <a:schemeClr val="tx1"/>
            </a:solidFill>
            <a:headEnd type="stealth" w="med" len="med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/>
          <p:nvPr/>
        </p:nvCxnSpPr>
        <p:spPr>
          <a:xfrm>
            <a:off x="2205578" y="2366404"/>
            <a:ext cx="2033427" cy="0"/>
          </a:xfrm>
          <a:prstGeom prst="straightConnector1">
            <a:avLst/>
          </a:prstGeom>
          <a:ln>
            <a:solidFill>
              <a:schemeClr val="tx1"/>
            </a:solidFill>
            <a:headEnd type="stealth" w="med" len="med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Oval 48"/>
          <p:cNvSpPr/>
          <p:nvPr/>
        </p:nvSpPr>
        <p:spPr>
          <a:xfrm>
            <a:off x="3068668" y="2224954"/>
            <a:ext cx="244106" cy="244106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050" dirty="0">
                <a:solidFill>
                  <a:schemeClr val="tx1"/>
                </a:solidFill>
              </a:rPr>
              <a:t>2</a:t>
            </a:r>
          </a:p>
        </p:txBody>
      </p:sp>
      <p:sp>
        <p:nvSpPr>
          <p:cNvPr id="50" name="Oval 49"/>
          <p:cNvSpPr/>
          <p:nvPr/>
        </p:nvSpPr>
        <p:spPr>
          <a:xfrm>
            <a:off x="1411950" y="2224954"/>
            <a:ext cx="244106" cy="244106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050" dirty="0">
                <a:solidFill>
                  <a:schemeClr val="tx1"/>
                </a:solidFill>
              </a:rPr>
              <a:t>1</a:t>
            </a:r>
          </a:p>
        </p:txBody>
      </p:sp>
      <p:cxnSp>
        <p:nvCxnSpPr>
          <p:cNvPr id="52" name="Straight Arrow Connector 51"/>
          <p:cNvCxnSpPr/>
          <p:nvPr/>
        </p:nvCxnSpPr>
        <p:spPr>
          <a:xfrm>
            <a:off x="4246789" y="2366404"/>
            <a:ext cx="1895646" cy="0"/>
          </a:xfrm>
          <a:prstGeom prst="straightConnector1">
            <a:avLst/>
          </a:prstGeom>
          <a:ln>
            <a:solidFill>
              <a:schemeClr val="tx1"/>
            </a:solidFill>
            <a:headEnd type="stealth" w="med" len="med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Oval 50"/>
          <p:cNvSpPr/>
          <p:nvPr/>
        </p:nvSpPr>
        <p:spPr>
          <a:xfrm>
            <a:off x="5081058" y="2224954"/>
            <a:ext cx="244106" cy="244106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050" dirty="0">
                <a:solidFill>
                  <a:schemeClr val="tx1"/>
                </a:solidFill>
              </a:rPr>
              <a:t>3</a:t>
            </a:r>
          </a:p>
        </p:txBody>
      </p:sp>
      <p:cxnSp>
        <p:nvCxnSpPr>
          <p:cNvPr id="55" name="Straight Arrow Connector 54"/>
          <p:cNvCxnSpPr/>
          <p:nvPr/>
        </p:nvCxnSpPr>
        <p:spPr>
          <a:xfrm>
            <a:off x="834457" y="4544817"/>
            <a:ext cx="3226908" cy="0"/>
          </a:xfrm>
          <a:prstGeom prst="straightConnector1">
            <a:avLst/>
          </a:prstGeom>
          <a:ln>
            <a:solidFill>
              <a:schemeClr val="tx1"/>
            </a:solidFill>
            <a:headEnd type="stealth" w="med" len="med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Oval 53"/>
          <p:cNvSpPr/>
          <p:nvPr/>
        </p:nvSpPr>
        <p:spPr>
          <a:xfrm>
            <a:off x="2325858" y="4421447"/>
            <a:ext cx="244106" cy="244106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050" dirty="0">
                <a:solidFill>
                  <a:schemeClr val="tx1"/>
                </a:solidFill>
              </a:rPr>
              <a:t>4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639529" y="7367667"/>
            <a:ext cx="2701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50" dirty="0"/>
              <a:t>1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1013689" y="7541339"/>
            <a:ext cx="2701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50" dirty="0"/>
              <a:t>2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973849" y="7134310"/>
            <a:ext cx="2701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50" dirty="0"/>
              <a:t>3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1480663" y="6571599"/>
            <a:ext cx="2701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50" dirty="0"/>
              <a:t>4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2547875" y="7265208"/>
            <a:ext cx="2701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50" dirty="0"/>
              <a:t>5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3216032" y="7336548"/>
            <a:ext cx="2701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50" dirty="0"/>
              <a:t>6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3898177" y="7606421"/>
            <a:ext cx="2701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50" dirty="0"/>
              <a:t>7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4362520" y="7311475"/>
            <a:ext cx="2701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50" dirty="0"/>
              <a:t>8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4013993" y="6284133"/>
            <a:ext cx="2701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50" dirty="0"/>
              <a:t>9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4590639" y="6493670"/>
            <a:ext cx="34489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50" dirty="0"/>
              <a:t>10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4873609" y="6092852"/>
            <a:ext cx="36512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50" dirty="0"/>
              <a:t>11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5879411" y="6138058"/>
            <a:ext cx="34489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50" dirty="0"/>
              <a:t>12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4229013" y="5650207"/>
            <a:ext cx="34489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50" dirty="0"/>
              <a:t>13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3853786" y="5440708"/>
            <a:ext cx="34489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50" dirty="0"/>
              <a:t>14</a:t>
            </a:r>
          </a:p>
        </p:txBody>
      </p:sp>
      <p:sp>
        <p:nvSpPr>
          <p:cNvPr id="89" name="TextBox 88"/>
          <p:cNvSpPr txBox="1"/>
          <p:nvPr/>
        </p:nvSpPr>
        <p:spPr>
          <a:xfrm>
            <a:off x="1975940" y="6584533"/>
            <a:ext cx="34489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50" dirty="0"/>
              <a:t>16</a:t>
            </a:r>
          </a:p>
        </p:txBody>
      </p:sp>
      <p:sp>
        <p:nvSpPr>
          <p:cNvPr id="90" name="TextBox 89"/>
          <p:cNvSpPr txBox="1"/>
          <p:nvPr/>
        </p:nvSpPr>
        <p:spPr>
          <a:xfrm>
            <a:off x="2483959" y="5801882"/>
            <a:ext cx="34489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50" dirty="0"/>
              <a:t>15</a:t>
            </a:r>
          </a:p>
        </p:txBody>
      </p:sp>
      <p:sp>
        <p:nvSpPr>
          <p:cNvPr id="91" name="TextBox 90"/>
          <p:cNvSpPr txBox="1"/>
          <p:nvPr/>
        </p:nvSpPr>
        <p:spPr>
          <a:xfrm>
            <a:off x="692630" y="1634790"/>
            <a:ext cx="416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800" b="1" dirty="0"/>
              <a:t>a</a:t>
            </a:r>
          </a:p>
        </p:txBody>
      </p:sp>
      <p:sp>
        <p:nvSpPr>
          <p:cNvPr id="92" name="TextBox 91"/>
          <p:cNvSpPr txBox="1"/>
          <p:nvPr/>
        </p:nvSpPr>
        <p:spPr>
          <a:xfrm>
            <a:off x="692630" y="5395576"/>
            <a:ext cx="416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8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4249005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</TotalTime>
  <Words>85</Words>
  <Application>Microsoft Office PowerPoint</Application>
  <PresentationFormat>A4 Paper (210x297 mm)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The University of Adelaid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imi Ann Gray</dc:creator>
  <cp:lastModifiedBy>Jaimi Gray</cp:lastModifiedBy>
  <cp:revision>5</cp:revision>
  <dcterms:created xsi:type="dcterms:W3CDTF">2017-11-23T03:38:57Z</dcterms:created>
  <dcterms:modified xsi:type="dcterms:W3CDTF">2018-04-26T04:29:26Z</dcterms:modified>
</cp:coreProperties>
</file>